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88518-AB52-4233-9503-B495674200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21FF5-461E-44F3-A00A-09FFC85E4C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251EB-3AC9-49B4-90D4-AF31CF3021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FAE02-3D99-4DB2-A451-0CAA785845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36AE0-3D8F-48CF-AC34-1E08C9EE0A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C561C-D0C6-43AF-890A-6607D34B07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95893-31D1-4386-86D1-BF4DD644F7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86796-8975-498F-A5B2-BBB65EF26B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297EC-A87D-490E-BF49-5C510A1DE9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318A2-6A21-499A-8722-B74F0EFDBD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EDD0F-D41A-427F-8FC4-0E069A31C2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90F54-90F2-400B-80E7-C0153ACF94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132FA8-669C-4A8C-91A3-F7161D4D7922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6600" y="66600"/>
            <a:ext cx="206712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914400" y="1187280"/>
            <a:ext cx="4648320" cy="6324840"/>
            <a:chOff x="914400" y="1187280"/>
            <a:chExt cx="4648320" cy="6324840"/>
          </a:xfrm>
        </p:grpSpPr>
        <p:grpSp>
          <p:nvGrpSpPr>
            <p:cNvPr id="43" name=""/>
            <p:cNvGrpSpPr/>
            <p:nvPr/>
          </p:nvGrpSpPr>
          <p:grpSpPr>
            <a:xfrm>
              <a:off x="1136520" y="1187280"/>
              <a:ext cx="4341960" cy="2974680"/>
              <a:chOff x="1136520" y="1187280"/>
              <a:chExt cx="4341960" cy="2974680"/>
            </a:xfrm>
          </p:grpSpPr>
          <p:pic>
            <p:nvPicPr>
              <p:cNvPr id="44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136520" y="1291320"/>
                <a:ext cx="4214520" cy="2870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"/>
              <p:cNvSpPr/>
              <p:nvPr/>
            </p:nvSpPr>
            <p:spPr>
              <a:xfrm>
                <a:off x="3268440" y="216072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136520" y="1187280"/>
                <a:ext cx="772560" cy="351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136520" y="2786760"/>
                <a:ext cx="667080" cy="117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136520" y="3447720"/>
                <a:ext cx="70200" cy="1389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5069880" y="3986640"/>
                <a:ext cx="280800" cy="86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960" bIns="3996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5070600" y="2472480"/>
                <a:ext cx="40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im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5070600" y="3889800"/>
                <a:ext cx="40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im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415880" y="2831760"/>
                <a:ext cx="854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cv. A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419120" y="1408680"/>
                <a:ext cx="1056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y mutant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881000" y="334332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467800" y="341280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2652480" y="292752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851200" y="354168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953800" y="334188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418640" y="292572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4016160" y="3695400"/>
                <a:ext cx="351360" cy="166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4082040" y="362304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"/>
            <p:cNvGrpSpPr/>
            <p:nvPr/>
          </p:nvGrpSpPr>
          <p:grpSpPr>
            <a:xfrm>
              <a:off x="914400" y="4464000"/>
              <a:ext cx="4630680" cy="3048120"/>
              <a:chOff x="914400" y="4464000"/>
              <a:chExt cx="4630680" cy="3048120"/>
            </a:xfrm>
          </p:grpSpPr>
          <p:grpSp>
            <p:nvGrpSpPr>
              <p:cNvPr id="63" name=""/>
              <p:cNvGrpSpPr/>
              <p:nvPr/>
            </p:nvGrpSpPr>
            <p:grpSpPr>
              <a:xfrm>
                <a:off x="1052640" y="4464000"/>
                <a:ext cx="4303080" cy="2844360"/>
                <a:chOff x="1052640" y="4464000"/>
                <a:chExt cx="4303080" cy="2844360"/>
              </a:xfrm>
            </p:grpSpPr>
            <p:pic>
              <p:nvPicPr>
                <p:cNvPr id="64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122840" y="4528800"/>
                  <a:ext cx="4215240" cy="2779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5" name=""/>
                <p:cNvSpPr/>
                <p:nvPr/>
              </p:nvSpPr>
              <p:spPr>
                <a:xfrm>
                  <a:off x="1052640" y="4464000"/>
                  <a:ext cx="816840" cy="3078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1105200" y="5995800"/>
                  <a:ext cx="772560" cy="129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1052640" y="6603480"/>
                  <a:ext cx="140400" cy="1296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5057280" y="7122240"/>
                  <a:ext cx="298440" cy="968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9" name=""/>
              <p:cNvSpPr/>
              <p:nvPr/>
            </p:nvSpPr>
            <p:spPr>
              <a:xfrm>
                <a:off x="5058360" y="5737320"/>
                <a:ext cx="40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im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058360" y="7057800"/>
                <a:ext cx="407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im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895040" y="65721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468160" y="634680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663280" y="606564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855520" y="671652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941200" y="636408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476240" y="614988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413720" y="6086520"/>
                <a:ext cx="867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cv. MT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392480" y="4722840"/>
                <a:ext cx="2209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35S:amiR-SlMYB1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3292200" y="522108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4068720" y="6669000"/>
                <a:ext cx="266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333399"/>
                    </a:solidFill>
                    <a:latin typeface="Times New Roman"/>
                    <a:ea typeface="Times New Roman"/>
                  </a:rPr>
                  <a:t>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914400" y="4594320"/>
                <a:ext cx="4630680" cy="29178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rot="16200000">
                <a:off x="426600" y="5881320"/>
                <a:ext cx="1252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just">
                  <a:lnSpc>
                    <a:spcPct val="100000"/>
                  </a:lnSpc>
                  <a:spcBef>
                    <a:spcPts val="1500"/>
                  </a:spcBef>
                  <a:spcAft>
                    <a:spcPts val="15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intensit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3" name=""/>
            <p:cNvGrpSpPr/>
            <p:nvPr/>
          </p:nvGrpSpPr>
          <p:grpSpPr>
            <a:xfrm>
              <a:off x="914400" y="1390680"/>
              <a:ext cx="4648320" cy="2916000"/>
              <a:chOff x="914400" y="1390680"/>
              <a:chExt cx="4648320" cy="2916000"/>
            </a:xfrm>
          </p:grpSpPr>
          <p:sp>
            <p:nvSpPr>
              <p:cNvPr id="84" name=""/>
              <p:cNvSpPr/>
              <p:nvPr/>
            </p:nvSpPr>
            <p:spPr>
              <a:xfrm>
                <a:off x="914400" y="1390680"/>
                <a:ext cx="4648320" cy="2916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rot="16200000">
                <a:off x="426600" y="2652480"/>
                <a:ext cx="1252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just">
                  <a:lnSpc>
                    <a:spcPct val="100000"/>
                  </a:lnSpc>
                  <a:spcBef>
                    <a:spcPts val="1500"/>
                  </a:spcBef>
                  <a:spcAft>
                    <a:spcPts val="15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intensit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4:34:18Z</dcterms:modified>
  <cp:revision>13</cp:revision>
  <dc:subject/>
  <dc:title>Slide 1</dc:title>
</cp:coreProperties>
</file>